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9A1E50-EE58-4CFD-9707-C4F48F0FBCF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CAA05E-5E43-490B-BFB8-7EEC3D47B80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BCF3C1-8AEE-446E-970B-9FA3CA7AAD1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EC8585-D248-4C15-BDD9-213B965AE27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2D7255-9C04-4B37-9803-88C5EBAD54A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1F18B0-FB39-4BC2-9C84-8F22039A779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5E77DB-F465-436F-83FA-9F590DF97D8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8D04EA-E50F-4E6D-BA34-E37810C29D6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E8A7AF-8318-47CA-8DFF-3B7FCF33AB0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84F17A-197D-4664-9AA5-97BCCAB08C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2CFF79-8FB4-407E-9903-3BD64FF3A39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B1C220-9B2A-4427-B540-ED6661F6968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7559B66-BA48-42DB-9062-99CEB5BAC8E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489040" y="4664160"/>
            <a:ext cx="292320" cy="8874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3289320" y="4178160"/>
            <a:ext cx="282600" cy="13766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4087800" y="5421240"/>
            <a:ext cx="293760" cy="1303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2781360" y="4273560"/>
            <a:ext cx="285840" cy="12780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3571920" y="4829040"/>
            <a:ext cx="285840" cy="7257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4381560" y="5168880"/>
            <a:ext cx="284040" cy="3826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 flipV="1">
            <a:off x="2635200" y="4566960"/>
            <a:ext cx="1800" cy="96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2611440" y="4567320"/>
            <a:ext cx="57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 flipV="1">
            <a:off x="3425760" y="4096800"/>
            <a:ext cx="1800" cy="81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3403440" y="4097160"/>
            <a:ext cx="558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 flipV="1">
            <a:off x="4233960" y="5389560"/>
            <a:ext cx="1440" cy="31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4210200" y="5389560"/>
            <a:ext cx="56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2635200" y="4664160"/>
            <a:ext cx="1800" cy="98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2611440" y="4762440"/>
            <a:ext cx="57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3425760" y="4178160"/>
            <a:ext cx="1800" cy="88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3403440" y="4267080"/>
            <a:ext cx="558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4233960" y="5421240"/>
            <a:ext cx="1440" cy="41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4210200" y="5462640"/>
            <a:ext cx="5688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 flipV="1">
            <a:off x="2919240" y="4135320"/>
            <a:ext cx="1800" cy="138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2895480" y="4135320"/>
            <a:ext cx="572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 flipV="1">
            <a:off x="3710160" y="4674960"/>
            <a:ext cx="1440" cy="153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3686040" y="4675320"/>
            <a:ext cx="57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 flipV="1">
            <a:off x="4519440" y="5087520"/>
            <a:ext cx="1800" cy="81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4494240" y="5087880"/>
            <a:ext cx="572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2919240" y="4273560"/>
            <a:ext cx="1800" cy="138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2895480" y="4411800"/>
            <a:ext cx="57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3710160" y="4829040"/>
            <a:ext cx="1440" cy="155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3686040" y="4984920"/>
            <a:ext cx="57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4519440" y="5168880"/>
            <a:ext cx="1800" cy="730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4494240" y="5241960"/>
            <a:ext cx="57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2403360" y="3865680"/>
            <a:ext cx="1800" cy="1685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2370240" y="5551560"/>
            <a:ext cx="331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2370240" y="5307120"/>
            <a:ext cx="331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2370240" y="5072040"/>
            <a:ext cx="33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2370240" y="4827600"/>
            <a:ext cx="33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2370240" y="4591080"/>
            <a:ext cx="331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2370240" y="4346640"/>
            <a:ext cx="331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2370240" y="4110120"/>
            <a:ext cx="331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2370240" y="3865680"/>
            <a:ext cx="3312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2403360" y="5551560"/>
            <a:ext cx="23385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 flipV="1">
            <a:off x="2403360" y="5551560"/>
            <a:ext cx="1800" cy="33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 flipV="1">
            <a:off x="3165480" y="5551560"/>
            <a:ext cx="1440" cy="33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 flipV="1">
            <a:off x="3963960" y="5554800"/>
            <a:ext cx="1440" cy="31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 flipV="1">
            <a:off x="4741920" y="5551560"/>
            <a:ext cx="1440" cy="33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680" bIns="-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2289240" y="548640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2232360" y="524196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2232360" y="500544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2232360" y="476244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2232360" y="452592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2232360" y="428148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2232360" y="404496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2232360" y="380052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7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2603160" y="5594400"/>
            <a:ext cx="3466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</a:rPr>
              <a:t>juvenil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3417480" y="5595840"/>
            <a:ext cx="307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</a:rPr>
              <a:t>femal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4266720" y="5594400"/>
            <a:ext cx="221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al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3895560" y="3960720"/>
            <a:ext cx="57240" cy="5724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3895560" y="4132440"/>
            <a:ext cx="57240" cy="568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080" bIns="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 rot="16200000">
            <a:off x="1363320" y="4500360"/>
            <a:ext cx="1497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% nematode per pla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1974600" y="35989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2791080" y="389880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3578400" y="443556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4391280" y="484344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2398680" y="2908440"/>
            <a:ext cx="122400" cy="4395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2822400" y="2581200"/>
            <a:ext cx="125640" cy="7668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3216240" y="3274920"/>
            <a:ext cx="123840" cy="73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3594240" y="2068560"/>
            <a:ext cx="125280" cy="12794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2523960" y="2965320"/>
            <a:ext cx="125640" cy="3826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2954160" y="3111480"/>
            <a:ext cx="125640" cy="2365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3348000" y="3243240"/>
            <a:ext cx="123840" cy="1047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3722760" y="2622600"/>
            <a:ext cx="122040" cy="7254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 flipV="1">
            <a:off x="2460600" y="2850840"/>
            <a:ext cx="1440" cy="572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2438280" y="2851200"/>
            <a:ext cx="540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 flipV="1">
            <a:off x="2886120" y="2484000"/>
            <a:ext cx="1440" cy="96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2863800" y="2484360"/>
            <a:ext cx="540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 flipV="1">
            <a:off x="3289320" y="3259080"/>
            <a:ext cx="1440" cy="15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3267000" y="3259080"/>
            <a:ext cx="525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 flipV="1">
            <a:off x="3649680" y="1928880"/>
            <a:ext cx="1440" cy="139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3625920" y="1928880"/>
            <a:ext cx="522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2460600" y="2908440"/>
            <a:ext cx="1440" cy="56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080" bIns="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2438280" y="2965320"/>
            <a:ext cx="540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2886120" y="2581200"/>
            <a:ext cx="1440" cy="90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2863800" y="2671920"/>
            <a:ext cx="540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3289320" y="3274920"/>
            <a:ext cx="1440" cy="15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3267000" y="3290760"/>
            <a:ext cx="5256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3649680" y="2068560"/>
            <a:ext cx="1440" cy="1299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3625920" y="2198520"/>
            <a:ext cx="522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 flipV="1">
            <a:off x="2587680" y="2908440"/>
            <a:ext cx="1440" cy="56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080" bIns="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2565360" y="2908440"/>
            <a:ext cx="540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 flipV="1">
            <a:off x="3017880" y="3063960"/>
            <a:ext cx="1440" cy="47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2994120" y="306396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 flipV="1">
            <a:off x="3411360" y="3218040"/>
            <a:ext cx="1800" cy="25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3387600" y="3218040"/>
            <a:ext cx="525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 flipV="1">
            <a:off x="3774960" y="2525400"/>
            <a:ext cx="1800" cy="968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3753000" y="2525760"/>
            <a:ext cx="5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2587680" y="2965320"/>
            <a:ext cx="1440" cy="65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2565360" y="3030480"/>
            <a:ext cx="540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3017880" y="3111480"/>
            <a:ext cx="1440" cy="41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2994120" y="3152880"/>
            <a:ext cx="540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3411360" y="3243240"/>
            <a:ext cx="1800" cy="23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3370320" y="3267000"/>
            <a:ext cx="540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3774960" y="2622600"/>
            <a:ext cx="1800" cy="90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3753000" y="2712960"/>
            <a:ext cx="540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2362320" y="1660680"/>
            <a:ext cx="1440" cy="1687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2332080" y="3348000"/>
            <a:ext cx="302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2332080" y="3014640"/>
            <a:ext cx="30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2332080" y="2671920"/>
            <a:ext cx="30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2332080" y="2336760"/>
            <a:ext cx="302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2332080" y="1995480"/>
            <a:ext cx="302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2332080" y="1660680"/>
            <a:ext cx="30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2362320" y="3348000"/>
            <a:ext cx="196668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 flipV="1">
            <a:off x="2362320" y="3347640"/>
            <a:ext cx="1440" cy="33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 flipV="1">
            <a:off x="2728800" y="3347640"/>
            <a:ext cx="1800" cy="33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 flipV="1">
            <a:off x="3154320" y="3347640"/>
            <a:ext cx="0" cy="33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 flipV="1">
            <a:off x="3527280" y="3347640"/>
            <a:ext cx="1800" cy="33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 flipV="1">
            <a:off x="4329000" y="3347640"/>
            <a:ext cx="1800" cy="33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2259000" y="328284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2259000" y="294948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2205360" y="260676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2205360" y="227160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2205360" y="192888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2205360" y="159552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2361960" y="3381480"/>
            <a:ext cx="3466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</a:rPr>
              <a:t>juvenil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2800080" y="3381480"/>
            <a:ext cx="307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</a:rPr>
              <a:t>femal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3229200" y="3381480"/>
            <a:ext cx="221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al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3630960" y="3381480"/>
            <a:ext cx="194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tota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2455920" y="1751040"/>
            <a:ext cx="54000" cy="57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2541960" y="1706400"/>
            <a:ext cx="651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35S-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gfp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NA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2455920" y="1922400"/>
            <a:ext cx="54000" cy="572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2532600" y="1889280"/>
            <a:ext cx="727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35S-</a:t>
            </a:r>
            <a:r>
              <a:rPr b="0" i="1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ecs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NA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 rot="16200000">
            <a:off x="1427400" y="2465280"/>
            <a:ext cx="136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Nematode per pla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1979640" y="12812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2899080" y="283680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>
            <a:off x="3654720" y="229716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74" name=""/>
          <p:cNvGrpSpPr/>
          <p:nvPr/>
        </p:nvGrpSpPr>
        <p:grpSpPr>
          <a:xfrm>
            <a:off x="4019400" y="1855440"/>
            <a:ext cx="128880" cy="1492560"/>
            <a:chOff x="4019400" y="1855440"/>
            <a:chExt cx="128880" cy="1492560"/>
          </a:xfrm>
        </p:grpSpPr>
        <p:sp>
          <p:nvSpPr>
            <p:cNvPr id="175" name=""/>
            <p:cNvSpPr/>
            <p:nvPr/>
          </p:nvSpPr>
          <p:spPr>
            <a:xfrm>
              <a:off x="4019400" y="1973520"/>
              <a:ext cx="128880" cy="13744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 flipV="1">
              <a:off x="4082040" y="1855440"/>
              <a:ext cx="1440" cy="117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"/>
            <p:cNvSpPr/>
            <p:nvPr/>
          </p:nvSpPr>
          <p:spPr>
            <a:xfrm>
              <a:off x="4073400" y="1855800"/>
              <a:ext cx="2232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>
              <a:off x="4082040" y="1973520"/>
              <a:ext cx="1440" cy="117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>
              <a:off x="4073400" y="2090880"/>
              <a:ext cx="2232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80" name=""/>
          <p:cNvGrpSpPr/>
          <p:nvPr/>
        </p:nvGrpSpPr>
        <p:grpSpPr>
          <a:xfrm>
            <a:off x="4149720" y="2924280"/>
            <a:ext cx="127080" cy="423720"/>
            <a:chOff x="4149720" y="2924280"/>
            <a:chExt cx="127080" cy="423720"/>
          </a:xfrm>
        </p:grpSpPr>
        <p:sp>
          <p:nvSpPr>
            <p:cNvPr id="181" name=""/>
            <p:cNvSpPr/>
            <p:nvPr/>
          </p:nvSpPr>
          <p:spPr>
            <a:xfrm>
              <a:off x="4149720" y="2938680"/>
              <a:ext cx="127080" cy="4093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 flipV="1">
              <a:off x="4211640" y="2924280"/>
              <a:ext cx="0" cy="14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4201200" y="2924280"/>
              <a:ext cx="2196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4211640" y="2938680"/>
              <a:ext cx="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4201200" y="2967120"/>
              <a:ext cx="21960" cy="3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86" name=""/>
          <p:cNvSpPr/>
          <p:nvPr/>
        </p:nvSpPr>
        <p:spPr>
          <a:xfrm rot="16200000">
            <a:off x="4001400" y="2400840"/>
            <a:ext cx="139860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Root (h)GSH content (nmolxg</a:t>
            </a:r>
            <a:r>
              <a:rPr b="1" lang="fr-FR" sz="1000" spc="-1" strike="noStrike" baseline="30000">
                <a:solidFill>
                  <a:srgbClr val="000000"/>
                </a:solidFill>
                <a:latin typeface="Arial"/>
              </a:rPr>
              <a:t>-1</a:t>
            </a: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 fresh weight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 flipV="1">
            <a:off x="3927600" y="3347640"/>
            <a:ext cx="1440" cy="33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>
            <a:off x="3992040" y="3379680"/>
            <a:ext cx="345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(h)GS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4327560" y="1714680"/>
            <a:ext cx="0" cy="1644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4355640" y="327816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4356000" y="2908440"/>
            <a:ext cx="1288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>
            <a:off x="4356000" y="2492280"/>
            <a:ext cx="1926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>
            <a:off x="4356000" y="2058840"/>
            <a:ext cx="1926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5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4356000" y="1643040"/>
            <a:ext cx="1926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>
            <a:off x="4325760" y="3349800"/>
            <a:ext cx="320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>
            <a:off x="4325760" y="2986200"/>
            <a:ext cx="320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>
            <a:off x="4325760" y="2565360"/>
            <a:ext cx="320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>
            <a:off x="4325760" y="2138400"/>
            <a:ext cx="32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>
            <a:off x="4325760" y="1708200"/>
            <a:ext cx="320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>
            <a:off x="4092120" y="270684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>
            <a:off x="4013640" y="3913200"/>
            <a:ext cx="651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35S-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gfp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NA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4004280" y="4095720"/>
            <a:ext cx="727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35S-</a:t>
            </a:r>
            <a:r>
              <a:rPr b="0" i="1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ecs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NA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>
            <a:off x="784080" y="7049880"/>
            <a:ext cx="5256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</a:rPr>
              <a:t>Figure S2.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>
            <a:off x="3929040" y="1725480"/>
            <a:ext cx="0" cy="164484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0-19T13:12:57Z</dcterms:created>
  <dc:creator>INRA</dc:creator>
  <dc:description/>
  <dc:language>en-US</dc:language>
  <cp:lastModifiedBy>INRA</cp:lastModifiedBy>
  <dcterms:modified xsi:type="dcterms:W3CDTF">2011-11-02T14:31:39Z</dcterms:modified>
  <cp:revision>10</cp:revision>
  <dc:subject/>
  <dc:title>Diapositive 1</dc:title>
</cp:coreProperties>
</file>